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3"/>
  </p:notesMasterIdLst>
  <p:handoutMasterIdLst>
    <p:handoutMasterId r:id="rId4"/>
  </p:handoutMasterIdLst>
  <p:sldIdLst>
    <p:sldId id="1831" r:id="rId2"/>
  </p:sldIdLst>
  <p:sldSz cx="12192000" cy="6858000"/>
  <p:notesSz cx="6735763" cy="986631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CC"/>
    <a:srgbClr val="FFCCFF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E8034E78-7F5D-4C2E-B375-FC64B27BC917}" styleName="スタイル (濃色)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濃色スタイル 1 - アクセント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DA37D80-6434-44D0-A028-1B22A696006F}" styleName="淡色スタイル 3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72833802-FEF1-4C79-8D5D-14CF1EAF98D9}" styleName="淡色スタイル 2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652" autoAdjust="0"/>
    <p:restoredTop sz="94694"/>
  </p:normalViewPr>
  <p:slideViewPr>
    <p:cSldViewPr snapToGrid="0">
      <p:cViewPr varScale="1">
        <p:scale>
          <a:sx n="82" d="100"/>
          <a:sy n="82" d="100"/>
        </p:scale>
        <p:origin x="720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Q8'!$I$4</c:f>
              <c:strCache>
                <c:ptCount val="1"/>
                <c:pt idx="0">
                  <c:v>話し合ったことがある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9C3D-4623-B5BD-9A493237B125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DF29-480A-B6AF-5825F0DA0EDB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9C3D-4623-B5BD-9A493237B125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C3D-4623-B5BD-9A493237B125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9C3D-4623-B5BD-9A493237B125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C3D-4623-B5BD-9A493237B125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Q8'!$G$5:$H$12</c:f>
              <c:multiLvlStrCache>
                <c:ptCount val="8"/>
                <c:lvl>
                  <c:pt idx="0">
                    <c:v>25–34</c:v>
                  </c:pt>
                  <c:pt idx="1">
                    <c:v>35–44</c:v>
                  </c:pt>
                  <c:pt idx="2">
                    <c:v>45–54</c:v>
                  </c:pt>
                  <c:pt idx="3">
                    <c:v>55–64</c:v>
                  </c:pt>
                  <c:pt idx="4">
                    <c:v>General</c:v>
                  </c:pt>
                  <c:pt idx="5">
                    <c:v>Physician</c:v>
                  </c:pt>
                  <c:pt idx="6">
                    <c:v>Nurse</c:v>
                  </c:pt>
                  <c:pt idx="7">
                    <c:v>Caregiver</c:v>
                  </c:pt>
                </c:lvl>
                <c:lvl>
                  <c:pt idx="0">
                    <c:v>Age (years)</c:v>
                  </c:pt>
                  <c:pt idx="4">
                    <c:v>Occupation</c:v>
                  </c:pt>
                </c:lvl>
              </c:multiLvlStrCache>
            </c:multiLvlStrRef>
          </c:cat>
          <c:val>
            <c:numRef>
              <c:f>'Q8'!$I$5:$I$12</c:f>
              <c:numCache>
                <c:formatCode>General</c:formatCode>
                <c:ptCount val="8"/>
                <c:pt idx="0">
                  <c:v>41.3</c:v>
                </c:pt>
                <c:pt idx="1">
                  <c:v>41.5</c:v>
                </c:pt>
                <c:pt idx="2">
                  <c:v>41.5</c:v>
                </c:pt>
                <c:pt idx="3">
                  <c:v>45.6</c:v>
                </c:pt>
                <c:pt idx="4">
                  <c:v>34.200000000000003</c:v>
                </c:pt>
                <c:pt idx="5" formatCode="0.0">
                  <c:v>42</c:v>
                </c:pt>
                <c:pt idx="6">
                  <c:v>43.4</c:v>
                </c:pt>
                <c:pt idx="7">
                  <c:v>5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5C-452C-8B96-D933216F33B1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023361600"/>
        <c:axId val="1023358688"/>
      </c:barChart>
      <c:catAx>
        <c:axId val="1023361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23358688"/>
        <c:crosses val="autoZero"/>
        <c:auto val="1"/>
        <c:lblAlgn val="ctr"/>
        <c:lblOffset val="100"/>
        <c:noMultiLvlLbl val="0"/>
      </c:catAx>
      <c:valAx>
        <c:axId val="1023358688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40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ercentage</a:t>
                </a:r>
                <a:r>
                  <a:rPr lang="en-US" altLang="ja-JP" sz="1400" baseline="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(</a:t>
                </a:r>
                <a:r>
                  <a:rPr lang="en-US" altLang="ja-JP" sz="140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%)</a:t>
                </a:r>
                <a:endParaRPr lang="ja-JP" altLang="en-US" sz="1400" dirty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6.6561844863731656E-3"/>
              <c:y val="7.706452991452991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23361600"/>
        <c:crosses val="autoZero"/>
        <c:crossBetween val="between"/>
        <c:majorUnit val="3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Q8'!$I$4</c:f>
              <c:strCache>
                <c:ptCount val="1"/>
                <c:pt idx="0">
                  <c:v>残している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9FAA-4140-BFD9-4EDB582501BC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A97-4054-980C-DC1A8DDDBB27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FAA-4140-BFD9-4EDB582501BC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9FAA-4140-BFD9-4EDB582501BC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FAA-4140-BFD9-4EDB582501BC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9FAA-4140-BFD9-4EDB582501B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Q8'!$G$5:$H$12</c:f>
              <c:multiLvlStrCache>
                <c:ptCount val="8"/>
                <c:lvl>
                  <c:pt idx="0">
                    <c:v>25–34</c:v>
                  </c:pt>
                  <c:pt idx="1">
                    <c:v>35–44</c:v>
                  </c:pt>
                  <c:pt idx="2">
                    <c:v>45–54</c:v>
                  </c:pt>
                  <c:pt idx="3">
                    <c:v>55–64</c:v>
                  </c:pt>
                  <c:pt idx="4">
                    <c:v>General</c:v>
                  </c:pt>
                  <c:pt idx="5">
                    <c:v>Physician</c:v>
                  </c:pt>
                  <c:pt idx="6">
                    <c:v>Nurse</c:v>
                  </c:pt>
                  <c:pt idx="7">
                    <c:v>Caregiver</c:v>
                  </c:pt>
                </c:lvl>
                <c:lvl>
                  <c:pt idx="0">
                    <c:v>Age (years)</c:v>
                  </c:pt>
                  <c:pt idx="4">
                    <c:v>Occupation</c:v>
                  </c:pt>
                </c:lvl>
              </c:multiLvlStrCache>
            </c:multiLvlStrRef>
          </c:cat>
          <c:val>
            <c:numRef>
              <c:f>'Q8'!$I$5:$I$12</c:f>
              <c:numCache>
                <c:formatCode>General</c:formatCode>
                <c:ptCount val="8"/>
                <c:pt idx="0">
                  <c:v>10.4</c:v>
                </c:pt>
                <c:pt idx="1">
                  <c:v>10.199999999999999</c:v>
                </c:pt>
                <c:pt idx="2">
                  <c:v>8.6999999999999993</c:v>
                </c:pt>
                <c:pt idx="3" formatCode="0.0">
                  <c:v>10</c:v>
                </c:pt>
                <c:pt idx="4">
                  <c:v>7.3</c:v>
                </c:pt>
                <c:pt idx="5">
                  <c:v>10.7</c:v>
                </c:pt>
                <c:pt idx="6">
                  <c:v>7.8</c:v>
                </c:pt>
                <c:pt idx="7" formatCode="0.0">
                  <c:v>13.6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C2-4716-B2E1-4B99DF65FBD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023361600"/>
        <c:axId val="1023358688"/>
      </c:barChart>
      <c:catAx>
        <c:axId val="1023361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defRPr>
            </a:pPr>
            <a:endParaRPr lang="ja-JP"/>
          </a:p>
        </c:txPr>
        <c:crossAx val="1023358688"/>
        <c:crosses val="autoZero"/>
        <c:auto val="1"/>
        <c:lblAlgn val="ctr"/>
        <c:lblOffset val="100"/>
        <c:noMultiLvlLbl val="0"/>
      </c:catAx>
      <c:valAx>
        <c:axId val="1023358688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40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ercentage</a:t>
                </a:r>
                <a:r>
                  <a:rPr lang="en-US" altLang="ja-JP" sz="1400" baseline="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(</a:t>
                </a:r>
                <a:r>
                  <a:rPr lang="en-US" altLang="ja-JP" sz="140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%)</a:t>
                </a:r>
                <a:endParaRPr lang="ja-JP" altLang="en-US" sz="1400" dirty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6.6561844863731656E-3"/>
              <c:y val="7.163717948717948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23361600"/>
        <c:crosses val="autoZero"/>
        <c:crossBetween val="between"/>
        <c:majorUnit val="3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D6743112-40A1-CF24-BD64-39A17CB707C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7825" cy="495300"/>
          </a:xfrm>
          <a:prstGeom prst="rect">
            <a:avLst/>
          </a:prstGeom>
        </p:spPr>
        <p:txBody>
          <a:bodyPr vert="horz" wrap="square" lIns="91367" tIns="45683" rIns="91367" bIns="45683" numCol="1" anchor="t" anchorCtr="0" compatLnSpc="1">
            <a:prstTxWarp prst="textNoShape">
              <a:avLst/>
            </a:prstTxWarp>
          </a:bodyPr>
          <a:lstStyle>
            <a:lvl1pPr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5C38DFC-E3CD-AB12-8965-A692C794EBCB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16350" y="0"/>
            <a:ext cx="2917825" cy="495300"/>
          </a:xfrm>
          <a:prstGeom prst="rect">
            <a:avLst/>
          </a:prstGeom>
        </p:spPr>
        <p:txBody>
          <a:bodyPr vert="horz" wrap="square" lIns="91367" tIns="45683" rIns="91367" bIns="45683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5B218D15-FD4B-48AC-9384-0B3FEA1CBE16}" type="datetimeFigureOut">
              <a:rPr lang="en-US" altLang="ja-JP"/>
              <a:pPr>
                <a:defRPr/>
              </a:pPr>
              <a:t>12/1/2023</a:t>
            </a:fld>
            <a:endParaRPr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5D12829-6066-B39B-1539-B4CE132C4A9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371013"/>
            <a:ext cx="2917825" cy="495300"/>
          </a:xfrm>
          <a:prstGeom prst="rect">
            <a:avLst/>
          </a:prstGeom>
        </p:spPr>
        <p:txBody>
          <a:bodyPr vert="horz" wrap="square" lIns="91367" tIns="45683" rIns="91367" bIns="45683" numCol="1" anchor="b" anchorCtr="0" compatLnSpc="1">
            <a:prstTxWarp prst="textNoShape">
              <a:avLst/>
            </a:prstTxWarp>
          </a:bodyPr>
          <a:lstStyle>
            <a:lvl1pPr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1DB5B7D-C7DB-DD80-81A4-531258DB75AB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16350" y="9371013"/>
            <a:ext cx="2917825" cy="495300"/>
          </a:xfrm>
          <a:prstGeom prst="rect">
            <a:avLst/>
          </a:prstGeom>
        </p:spPr>
        <p:txBody>
          <a:bodyPr vert="horz" wrap="square" lIns="91367" tIns="45683" rIns="91367" bIns="45683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27C05DDD-6A0D-4F46-A958-A21C2E104A1D}" type="slidenum">
              <a:rPr lang="en-US" altLang="ja-JP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8C8F1F74-06AE-0054-B811-2C4B25744FA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2125"/>
          </a:xfrm>
          <a:prstGeom prst="rect">
            <a:avLst/>
          </a:prstGeom>
        </p:spPr>
        <p:txBody>
          <a:bodyPr vert="horz" wrap="square" lIns="90743" tIns="45373" rIns="90743" bIns="45373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072D79C-A9EB-A2B4-5341-024D98CCD569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2125"/>
          </a:xfrm>
          <a:prstGeom prst="rect">
            <a:avLst/>
          </a:prstGeom>
        </p:spPr>
        <p:txBody>
          <a:bodyPr vert="horz" wrap="square" lIns="90743" tIns="45373" rIns="90743" bIns="45373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7D7854C3-277B-4B24-9C77-8A0526121FE3}" type="datetimeFigureOut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4" name="スライド イメージ プレースホルダー 3">
            <a:extLst>
              <a:ext uri="{FF2B5EF4-FFF2-40B4-BE49-F238E27FC236}">
                <a16:creationId xmlns:a16="http://schemas.microsoft.com/office/drawing/2014/main" id="{B3C580DB-0DE3-46D8-4AEE-EF87AB1A40EF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79375" y="739775"/>
            <a:ext cx="657701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43" tIns="45373" rIns="90743" bIns="45373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>
            <a:extLst>
              <a:ext uri="{FF2B5EF4-FFF2-40B4-BE49-F238E27FC236}">
                <a16:creationId xmlns:a16="http://schemas.microsoft.com/office/drawing/2014/main" id="{11C1756D-A817-4879-86D3-A205D92277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4688" y="4684713"/>
            <a:ext cx="5386387" cy="4441825"/>
          </a:xfrm>
          <a:prstGeom prst="rect">
            <a:avLst/>
          </a:prstGeom>
        </p:spPr>
        <p:txBody>
          <a:bodyPr vert="horz" wrap="square" lIns="90743" tIns="45373" rIns="90743" bIns="4537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ー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C86D3E1-C543-91D7-3F6A-4E0DB4C52C21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372600"/>
            <a:ext cx="2919413" cy="492125"/>
          </a:xfrm>
          <a:prstGeom prst="rect">
            <a:avLst/>
          </a:prstGeom>
        </p:spPr>
        <p:txBody>
          <a:bodyPr vert="horz" wrap="square" lIns="90743" tIns="45373" rIns="90743" bIns="45373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F2C9C07-BB1D-87CB-E42C-92923EBFFAF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14763" y="9372600"/>
            <a:ext cx="2919412" cy="492125"/>
          </a:xfrm>
          <a:prstGeom prst="rect">
            <a:avLst/>
          </a:prstGeom>
        </p:spPr>
        <p:txBody>
          <a:bodyPr vert="horz" wrap="square" lIns="90743" tIns="45373" rIns="90743" bIns="45373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94690663-899B-4EFA-B643-223F29E83C7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スライド イメージ プレースホルダー 1">
            <a:extLst>
              <a:ext uri="{FF2B5EF4-FFF2-40B4-BE49-F238E27FC236}">
                <a16:creationId xmlns:a16="http://schemas.microsoft.com/office/drawing/2014/main" id="{5AC466E8-E27A-404E-AC61-500C86344ECF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1267" name="ノート プレースホルダー 2">
            <a:extLst>
              <a:ext uri="{FF2B5EF4-FFF2-40B4-BE49-F238E27FC236}">
                <a16:creationId xmlns:a16="http://schemas.microsoft.com/office/drawing/2014/main" id="{919112B1-7E94-485F-BBA9-30E81490B65A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dirty="0"/>
          </a:p>
        </p:txBody>
      </p:sp>
      <p:sp>
        <p:nvSpPr>
          <p:cNvPr id="11268" name="スライド番号プレースホルダー 3">
            <a:extLst>
              <a:ext uri="{FF2B5EF4-FFF2-40B4-BE49-F238E27FC236}">
                <a16:creationId xmlns:a16="http://schemas.microsoft.com/office/drawing/2014/main" id="{0E123DD0-3ABE-4BFE-A0B7-B6507F49772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7713" indent="-28575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52525" indent="-227013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14488" indent="-227013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74863" indent="-227013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32063" indent="-227013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89263" indent="-227013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46463" indent="-227013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903663" indent="-227013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</a:pPr>
            <a:fld id="{D012B33D-DFFE-423B-87A4-5E2AAA055511}" type="slidenum">
              <a:rPr lang="ja-JP" altLang="en-US" smtClean="0"/>
              <a:pPr>
                <a:spcBef>
                  <a:spcPct val="0"/>
                </a:spcBef>
              </a:pPr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319620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33"/>
            <a:ext cx="103632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84BB18-7E04-1245-5FFB-4B4DFACD7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890C49-9CD2-492F-A985-3F30161D5999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2F44FC2-FFDC-4DCC-165A-E1D0039A2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D7781F-9289-1C0C-EE9B-55E4D1D8B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E17C6B-6D8E-4255-AAA8-059CD8B659C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8928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FCD7BD-A5BE-B466-F8C0-639EABB92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84B85B-8250-4796-BFC9-B47DCB0A715D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C9E757-CC78-FB94-8C7A-33447B66C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CCF139-7FE7-8721-6F70-4D107ADF6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AAD9-634A-4702-A7D6-8876F7A87BB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15131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9575799" y="274646"/>
            <a:ext cx="2971801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60404" y="274646"/>
            <a:ext cx="8712201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65C398-C3F6-B701-D4F6-64F87E08E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455061-5C5B-4435-9702-9F99DB62BE11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8843CA-63B8-600E-B745-4242F89EA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F215C0-8DAB-552D-FE5C-35B04A761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A81A39-73DF-4C96-98B8-B3F61E1DBD5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87464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0AE6E8-2983-1AF4-E298-F1F0B0B6D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2051FE-583A-4FC9-AD46-40E39C7483DA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565CEF-D53E-2435-7196-EE6D5A1A2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BCACFB-C71B-A967-7C3F-F7D7DE0D7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7CEAB-F491-4213-B105-83CDCA349BA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05364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8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A75AC5-776A-67A8-C03C-AF6BE0716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4D1A1-0192-4FEB-AE2C-2B3172D39E6D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47E598-C96F-BF45-5B87-7FF987C2E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4E177F-8F3E-2D74-AF61-1A0D6E74C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507F47-4B18-445B-9D49-C53EEF766D9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1035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60401" y="1600206"/>
            <a:ext cx="58420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705601" y="1600206"/>
            <a:ext cx="58420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2D4D1C20-B189-B3AF-0585-4B210B89A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9BC02D-8464-4C57-8BC5-B16CDF6AC0AE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CE4286D6-6C62-647E-13F4-5C47054ED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1A7CE18C-B4AE-9E13-F004-8F65942D7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4A6B05-D29A-48D0-A583-338C4EA6BBC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98891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71" y="1535113"/>
            <a:ext cx="538903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71" y="2174875"/>
            <a:ext cx="538903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>
            <a:extLst>
              <a:ext uri="{FF2B5EF4-FFF2-40B4-BE49-F238E27FC236}">
                <a16:creationId xmlns:a16="http://schemas.microsoft.com/office/drawing/2014/main" id="{0A7827E1-770C-1CA1-B74C-85927501F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6A2F0B-D8F7-48D8-A2DB-6740B2E4A662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8" name="フッター プレースホルダー 4">
            <a:extLst>
              <a:ext uri="{FF2B5EF4-FFF2-40B4-BE49-F238E27FC236}">
                <a16:creationId xmlns:a16="http://schemas.microsoft.com/office/drawing/2014/main" id="{B3A53CC7-CCF1-880B-2629-B9A6D3707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>
            <a:extLst>
              <a:ext uri="{FF2B5EF4-FFF2-40B4-BE49-F238E27FC236}">
                <a16:creationId xmlns:a16="http://schemas.microsoft.com/office/drawing/2014/main" id="{C6C4FB0E-8372-0CFC-93F9-061AFA16E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98D256-F712-4452-8BA1-D45D0F72A6B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62015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>
            <a:extLst>
              <a:ext uri="{FF2B5EF4-FFF2-40B4-BE49-F238E27FC236}">
                <a16:creationId xmlns:a16="http://schemas.microsoft.com/office/drawing/2014/main" id="{943FB045-9D13-B4CE-1A2D-ED17CC15D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2E0FD7-C44C-43E9-A42D-885E636FA749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4" name="フッター プレースホルダー 4">
            <a:extLst>
              <a:ext uri="{FF2B5EF4-FFF2-40B4-BE49-F238E27FC236}">
                <a16:creationId xmlns:a16="http://schemas.microsoft.com/office/drawing/2014/main" id="{94F4777C-4552-7DDE-8F8A-E162026FD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>
            <a:extLst>
              <a:ext uri="{FF2B5EF4-FFF2-40B4-BE49-F238E27FC236}">
                <a16:creationId xmlns:a16="http://schemas.microsoft.com/office/drawing/2014/main" id="{483128B8-144B-40E6-DB36-6087C4BF5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C1D279-3FEE-46AB-A930-7DBF16D37AB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91345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>
            <a:extLst>
              <a:ext uri="{FF2B5EF4-FFF2-40B4-BE49-F238E27FC236}">
                <a16:creationId xmlns:a16="http://schemas.microsoft.com/office/drawing/2014/main" id="{24C0FC43-4054-E4E0-05F5-BF1B3A103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3340E2-3349-4361-ACEF-50E35F3FE58A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3" name="フッター プレースホルダー 4">
            <a:extLst>
              <a:ext uri="{FF2B5EF4-FFF2-40B4-BE49-F238E27FC236}">
                <a16:creationId xmlns:a16="http://schemas.microsoft.com/office/drawing/2014/main" id="{9A8F5AC5-0928-96EE-2B6C-46091A86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>
            <a:extLst>
              <a:ext uri="{FF2B5EF4-FFF2-40B4-BE49-F238E27FC236}">
                <a16:creationId xmlns:a16="http://schemas.microsoft.com/office/drawing/2014/main" id="{C88A6335-8AF8-1C97-70AD-788A6721C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AFCF7D-412F-437B-925E-A1CD0480E2D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70922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0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6" y="273058"/>
            <a:ext cx="6815666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0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6453978D-18D0-D730-9B68-296E523B9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BB6721-6685-4476-9F7E-208E2A668E43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C98CB824-E953-FBA8-31C4-0F0929064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2294B84F-8FD8-62DA-5F3F-1A8EE8F32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2D41FE-542E-47C4-AC38-AA58B7D1025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73877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FEACDEE3-87E0-3FE9-E88F-B781D2583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4FF98C-2D41-414C-9913-C9C13F8822F2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2854F57A-1F4A-0129-1C04-D8E3DB44F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B57CD52B-9D65-8B62-9A2B-FF7559924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785C45-55C0-4E43-9347-3E66DB8930D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67734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A045A50A-5E74-3AF6-F2C4-14102A4B3627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0184E445-7936-28DF-9C46-73EE40556260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09600" y="1600200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F1291E-4E52-D485-8474-D39C3160A2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09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9BDBBC19-C59E-469B-AA6F-D5E5D1DFE98C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F4AB11-476F-9758-A0A6-8CE6326E30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165600" y="6356350"/>
            <a:ext cx="3860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BE4AF4-DCBC-B77F-B934-51EA8786DE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737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C01CCA4D-91EF-4C09-B914-11D11F9125F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2DC531F0-8252-9D26-9ED9-49ED52D0EC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893754"/>
              </p:ext>
            </p:extLst>
          </p:nvPr>
        </p:nvGraphicFramePr>
        <p:xfrm>
          <a:off x="592325" y="1262490"/>
          <a:ext cx="954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F936547A-13C3-7D04-C776-3D071445CA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8146482"/>
              </p:ext>
            </p:extLst>
          </p:nvPr>
        </p:nvGraphicFramePr>
        <p:xfrm>
          <a:off x="592318" y="4107514"/>
          <a:ext cx="954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2D9FB5E-1482-7D8A-97D2-57C31D9440F6}"/>
              </a:ext>
            </a:extLst>
          </p:cNvPr>
          <p:cNvSpPr txBox="1"/>
          <p:nvPr/>
        </p:nvSpPr>
        <p:spPr>
          <a:xfrm>
            <a:off x="4156499" y="3453861"/>
            <a:ext cx="12915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523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0AD38B6-8AB0-97A6-6A46-4167B7CEB9F3}"/>
              </a:ext>
            </a:extLst>
          </p:cNvPr>
          <p:cNvSpPr txBox="1"/>
          <p:nvPr/>
        </p:nvSpPr>
        <p:spPr>
          <a:xfrm>
            <a:off x="8260572" y="3453861"/>
            <a:ext cx="15996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lang="ja-JP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AEF5DA3-588A-54F0-FBC2-452B8E531B58}"/>
              </a:ext>
            </a:extLst>
          </p:cNvPr>
          <p:cNvSpPr txBox="1"/>
          <p:nvPr/>
        </p:nvSpPr>
        <p:spPr>
          <a:xfrm>
            <a:off x="4276157" y="6154194"/>
            <a:ext cx="11718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851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BA7E7FB-33F2-F940-5068-9D66370D46EA}"/>
              </a:ext>
            </a:extLst>
          </p:cNvPr>
          <p:cNvSpPr txBox="1"/>
          <p:nvPr/>
        </p:nvSpPr>
        <p:spPr>
          <a:xfrm>
            <a:off x="8260567" y="6156484"/>
            <a:ext cx="15996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08</a:t>
            </a:r>
            <a:endParaRPr lang="ja-JP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A05EDE6-90C3-AA50-7288-E0FA5555F1D4}"/>
              </a:ext>
            </a:extLst>
          </p:cNvPr>
          <p:cNvSpPr txBox="1"/>
          <p:nvPr/>
        </p:nvSpPr>
        <p:spPr>
          <a:xfrm>
            <a:off x="5944119" y="1404783"/>
            <a:ext cx="537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kumimoji="1" lang="ja-JP" altLang="en-US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0BFCA48-00A1-0983-CD41-87795C3FE472}"/>
              </a:ext>
            </a:extLst>
          </p:cNvPr>
          <p:cNvSpPr txBox="1"/>
          <p:nvPr/>
        </p:nvSpPr>
        <p:spPr>
          <a:xfrm>
            <a:off x="9173198" y="1020074"/>
            <a:ext cx="5378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3200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ED02BA7-AAFD-98EC-6428-33494BFEDAF5}"/>
              </a:ext>
            </a:extLst>
          </p:cNvPr>
          <p:cNvSpPr txBox="1"/>
          <p:nvPr/>
        </p:nvSpPr>
        <p:spPr>
          <a:xfrm>
            <a:off x="5952578" y="4892291"/>
            <a:ext cx="537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kumimoji="1" lang="ja-JP" altLang="en-US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69B66E3-72CC-9C85-EE5A-46C33C27593E}"/>
              </a:ext>
            </a:extLst>
          </p:cNvPr>
          <p:cNvSpPr txBox="1"/>
          <p:nvPr/>
        </p:nvSpPr>
        <p:spPr>
          <a:xfrm>
            <a:off x="9181667" y="4679313"/>
            <a:ext cx="5378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3200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B5E669E-7EE8-2A1B-C275-C038BF24B22F}"/>
              </a:ext>
            </a:extLst>
          </p:cNvPr>
          <p:cNvSpPr txBox="1"/>
          <p:nvPr/>
        </p:nvSpPr>
        <p:spPr>
          <a:xfrm>
            <a:off x="261257" y="125592"/>
            <a:ext cx="1177834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2. Respondents with experience discussing and documenting future treatment and care preferences of grandparents and parents</a:t>
            </a:r>
            <a:endParaRPr lang="ja-JP" altLang="en-US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6BD0764-D5BF-D6BA-BB29-E98440AFE8FC}"/>
              </a:ext>
            </a:extLst>
          </p:cNvPr>
          <p:cNvSpPr txBox="1"/>
          <p:nvPr/>
        </p:nvSpPr>
        <p:spPr>
          <a:xfrm>
            <a:off x="587829" y="6501319"/>
            <a:ext cx="11132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14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Statistically higher for adjusted residual (&gt;1.96), †Statistically lower for adjusted residual (&lt;-1.96)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8A67B94-7D25-1C4A-E8C7-7FB5C7AD2619}"/>
              </a:ext>
            </a:extLst>
          </p:cNvPr>
          <p:cNvSpPr txBox="1"/>
          <p:nvPr/>
        </p:nvSpPr>
        <p:spPr>
          <a:xfrm>
            <a:off x="582897" y="877015"/>
            <a:ext cx="65301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44" indent="-285744">
              <a:buFont typeface="Wingdings" panose="05000000000000000000" pitchFamily="2" charset="2"/>
              <a:buChar char="n"/>
              <a:defRPr/>
            </a:pPr>
            <a:r>
              <a:rPr lang="en-US" altLang="ja-JP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iscussed</a:t>
            </a:r>
            <a:endParaRPr lang="ja-JP" altLang="en-US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1E4D885-188A-16B3-6D9B-8039BDC33289}"/>
              </a:ext>
            </a:extLst>
          </p:cNvPr>
          <p:cNvSpPr txBox="1"/>
          <p:nvPr/>
        </p:nvSpPr>
        <p:spPr>
          <a:xfrm>
            <a:off x="582893" y="3685313"/>
            <a:ext cx="67926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44" indent="-285744">
              <a:buFont typeface="Wingdings" panose="05000000000000000000" pitchFamily="2" charset="2"/>
              <a:buChar char="n"/>
              <a:defRPr/>
            </a:pPr>
            <a:r>
              <a:rPr lang="en-US" altLang="ja-JP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ocumented</a:t>
            </a:r>
            <a:endParaRPr lang="ja-JP" altLang="en-US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0707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85</TotalTime>
  <Words>59</Words>
  <Application>Microsoft Office PowerPoint</Application>
  <PresentationFormat>ワイド画面</PresentationFormat>
  <Paragraphs>1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Office ​​テーマ</vt:lpstr>
      <vt:lpstr>PowerPoint プレゼンテーション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NISHI</dc:creator>
  <cp:lastModifiedBy>中西康裕</cp:lastModifiedBy>
  <cp:revision>1101</cp:revision>
  <cp:lastPrinted>2022-06-03T09:43:16Z</cp:lastPrinted>
  <dcterms:created xsi:type="dcterms:W3CDTF">2014-06-20T06:24:21Z</dcterms:created>
  <dcterms:modified xsi:type="dcterms:W3CDTF">2023-12-01T09:10:12Z</dcterms:modified>
</cp:coreProperties>
</file>